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2" r:id="rId3"/>
    <p:sldId id="263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5214" autoAdjust="0"/>
  </p:normalViewPr>
  <p:slideViewPr>
    <p:cSldViewPr snapToGrid="0">
      <p:cViewPr varScale="1">
        <p:scale>
          <a:sx n="82" d="100"/>
          <a:sy n="82" d="100"/>
        </p:scale>
        <p:origin x="17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systemanalytic365.sharepoint.com/sites/SharepointFileStorage/Marketing%20%20PR/Thought%20Leader%20Pieces/03.%20Early%20Access%20Provision%202020/03.%20Deliverables/EAP%20Raw%20Data%2019.0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365-42E2-AACC-56C71022657E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365-42E2-AACC-56C71022657E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365-42E2-AACC-56C71022657E}"/>
              </c:ext>
            </c:extLst>
          </c:dPt>
          <c:dLbls>
            <c:dLbl>
              <c:idx val="0"/>
              <c:layout>
                <c:manualLayout>
                  <c:x val="-9.1679609063671799E-2"/>
                  <c:y val="0.1431730300019165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A365-42E2-AACC-56C71022657E}"/>
                </c:ext>
              </c:extLst>
            </c:dLbl>
            <c:dLbl>
              <c:idx val="1"/>
              <c:layout>
                <c:manualLayout>
                  <c:x val="8.334509914879204E-3"/>
                  <c:y val="-0.23776949625318283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A365-42E2-AACC-56C71022657E}"/>
                </c:ext>
              </c:extLst>
            </c:dLbl>
            <c:dLbl>
              <c:idx val="2"/>
              <c:layout>
                <c:manualLayout>
                  <c:x val="8.5726387695900824E-2"/>
                  <c:y val="0.16618298125222444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A365-42E2-AACC-56C71022657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[EAP Raw Data 19.02.xlsx]Region'!$G$3:$G$5</c:f>
              <c:strCache>
                <c:ptCount val="3"/>
                <c:pt idx="0">
                  <c:v>APAC</c:v>
                </c:pt>
                <c:pt idx="1">
                  <c:v>Europe</c:v>
                </c:pt>
                <c:pt idx="2">
                  <c:v>North America</c:v>
                </c:pt>
              </c:strCache>
            </c:strRef>
          </c:cat>
          <c:val>
            <c:numRef>
              <c:f>'[EAP Raw Data 19.02.xlsx]Region'!$H$3:$H$5</c:f>
              <c:numCache>
                <c:formatCode>0%</c:formatCode>
                <c:ptCount val="3"/>
                <c:pt idx="0">
                  <c:v>0.27</c:v>
                </c:pt>
                <c:pt idx="1">
                  <c:v>0.5</c:v>
                </c:pt>
                <c:pt idx="2">
                  <c:v>0.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365-42E2-AACC-56C7102265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0948718835167468"/>
          <c:y val="0.3024526232552297"/>
          <c:w val="0.23472404406548897"/>
          <c:h val="0.2674915891884231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Country breakdown</a:t>
            </a:r>
          </a:p>
        </c:rich>
      </c:tx>
      <c:layout>
        <c:manualLayout>
          <c:xMode val="edge"/>
          <c:yMode val="edge"/>
          <c:x val="0.37173224550823403"/>
          <c:y val="2.912333877293856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DE"/>
        </a:p>
      </c:txPr>
    </c:title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C72-4CA2-93FB-54C83EDE3792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C72-4CA2-93FB-54C83EDE3792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C72-4CA2-93FB-54C83EDE3792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C72-4CA2-93FB-54C83EDE3792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5C72-4CA2-93FB-54C83EDE3792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5C72-4CA2-93FB-54C83EDE3792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5C72-4CA2-93FB-54C83EDE3792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5C72-4CA2-93FB-54C83EDE3792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5C72-4CA2-93FB-54C83EDE3792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5C72-4CA2-93FB-54C83EDE3792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5C72-4CA2-93FB-54C83EDE3792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5C72-4CA2-93FB-54C83EDE3792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DE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[EAP Raw Data 19.02.xlsx]Region'!$G$8:$G$19</c:f>
              <c:strCache>
                <c:ptCount val="12"/>
                <c:pt idx="0">
                  <c:v>Australia</c:v>
                </c:pt>
                <c:pt idx="1">
                  <c:v>Canada</c:v>
                </c:pt>
                <c:pt idx="2">
                  <c:v>China</c:v>
                </c:pt>
                <c:pt idx="3">
                  <c:v>France</c:v>
                </c:pt>
                <c:pt idx="4">
                  <c:v>Germany</c:v>
                </c:pt>
                <c:pt idx="5">
                  <c:v>Italy</c:v>
                </c:pt>
                <c:pt idx="6">
                  <c:v>Japan</c:v>
                </c:pt>
                <c:pt idx="7">
                  <c:v>South Korea</c:v>
                </c:pt>
                <c:pt idx="8">
                  <c:v>Spain</c:v>
                </c:pt>
                <c:pt idx="9">
                  <c:v>Taiwan</c:v>
                </c:pt>
                <c:pt idx="10">
                  <c:v>United Kingdom</c:v>
                </c:pt>
                <c:pt idx="11">
                  <c:v>United States</c:v>
                </c:pt>
              </c:strCache>
            </c:strRef>
          </c:cat>
          <c:val>
            <c:numRef>
              <c:f>'[EAP Raw Data 19.02.xlsx]Region'!$H$8:$H$19</c:f>
              <c:numCache>
                <c:formatCode>General</c:formatCode>
                <c:ptCount val="12"/>
                <c:pt idx="0">
                  <c:v>3</c:v>
                </c:pt>
                <c:pt idx="1">
                  <c:v>5</c:v>
                </c:pt>
                <c:pt idx="2">
                  <c:v>1</c:v>
                </c:pt>
                <c:pt idx="3">
                  <c:v>5</c:v>
                </c:pt>
                <c:pt idx="4">
                  <c:v>5</c:v>
                </c:pt>
                <c:pt idx="5">
                  <c:v>16</c:v>
                </c:pt>
                <c:pt idx="6">
                  <c:v>1</c:v>
                </c:pt>
                <c:pt idx="7">
                  <c:v>4</c:v>
                </c:pt>
                <c:pt idx="8">
                  <c:v>14</c:v>
                </c:pt>
                <c:pt idx="9">
                  <c:v>3</c:v>
                </c:pt>
                <c:pt idx="10">
                  <c:v>4</c:v>
                </c:pt>
                <c:pt idx="11">
                  <c:v>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5C72-4CA2-93FB-54C83EDE37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75649138908968117"/>
          <c:y val="8.0501612496199748E-2"/>
          <c:w val="0.16238248316132467"/>
          <c:h val="0.7732250303342210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C60FE9-566C-4D95-9304-401478008E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9B49D3B-AFAE-4FCE-86E6-515C541917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70AB1A-BB09-4DC7-9DDA-04302E7CAF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BCF127-C4DB-47AB-BABC-2165143518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3D5EEE-8411-4306-9019-EA284A8F47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455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54A676-CB94-4DDF-B349-59436C5E45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A21B5BC-5FB7-460D-B6C3-97897F7645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3F0FAD-8A9C-4797-9712-ADC028C0AD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DA043F-45C6-402B-B8E0-B8D1240E2C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D84154-F9ED-41F8-A5C9-D1ED30449C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3827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06BDB66-BEA0-401C-BCA1-AF456A971E8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237161-9F41-4DC9-B35F-EBC2C1279E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6CB68E-250A-463A-AE06-4D42E146B3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A8C4BF-BC95-40D3-95EA-0AB576787A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F6091E-421F-462F-84F1-33ECF01C0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9667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88BC7D-AB0D-4AC7-8EAB-3F0570B715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7DAD68-F6CD-40CB-82D4-7A4B321CA0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374B1B-DABA-419C-8E1D-F3D7E08F69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406877-630B-4658-ADE7-DB4FDB9816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7F129F-E00E-46CC-8478-8D53C7973B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3146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3A50A8-F3A6-4D3E-B313-DEF6A3E33E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8C18B2-6DE4-48E7-8B96-BA8C85D0DE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1AD6B4-A94F-4CA4-8654-87F4C420E0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CFE9D5-EB32-4A51-97E3-82742131C4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CE3288-14D7-4252-8841-95697ACD3B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3872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4263EE-0D6C-4DC3-A033-63FC2D204D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646ADC-CF01-44D7-A32A-3072C858CB5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CE8946B-EA93-4292-A38C-70E4F6CE4A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D3A1F2-89B8-40B9-9913-9E51C30A8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29439B-99D1-496F-BA97-A1A470C3CD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B852E6-4557-48B1-9344-A4176A5186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292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F7DF59-D8DB-42C7-9D6D-2324E6B5FC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B04F8E-912B-4644-AE6E-778AD09319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5C88E0-8A64-4157-9CCC-326B324E27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4251E89-7B6C-4909-9013-52E8E27B99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3E9C570-FBD9-48AA-8844-03861D1947C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B6DF997-366A-4433-A0B3-3F4A70B0F7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6787223-6F68-4D82-99E5-9B93456BA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F457904-6528-4962-8799-D344B9811F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926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599DAA-8BB5-418A-8DD7-92FA9FAF01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D9FB9E9-7F97-4014-AC6F-D5C409C023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A6C7FF6-5BB4-491F-ABDB-F79F5567DD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786CF20-280E-4CF1-8E34-BDCCC0FA9E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6957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CD37C83-1465-40FA-B60C-5A757A629F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B49D5DF-A388-42DF-AAC6-50E873BAF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424C439-7602-4E6C-93D8-AB9C9AC956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404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7AF85D-A3C7-40C0-AE79-2658B05014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5D882E-166A-4741-8CAB-8B87F8601F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9B494D-1B4C-4B7C-81C2-ED69154AC3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4E7A9F-92AF-4AA5-91D8-0D990E1CD8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AD82ED-ABBD-4ECA-B66B-92A2A01021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2807BD-04BF-4C15-8702-78A0498A48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299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1B39FC-52B2-43AF-BFD4-2BC6A58672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0A64028-D7E6-40DE-9DB2-4C6B805434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7A8C7E-5AD9-44E8-9FA9-0A142B11A3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64AE9D-6A51-4461-8D4B-182B72DE9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0B7836-440A-479A-AA19-4F6F8F216F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F1617F-18C7-43B7-97CF-CD2D917264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888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021F483-1254-4497-A2AE-DD9D65EA82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CB1193-95B1-4422-AA91-D776F58B68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05CB6A-D727-4D63-A7E8-220E3441233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C933E5-4CC0-41F1-B0D1-A9A2EBE7DB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BAEE3A-31CE-4B95-AC24-963217E53B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7778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69B8FD-400E-4DFD-8145-03EA3B5C21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3999" y="1122363"/>
            <a:ext cx="9738049" cy="2387600"/>
          </a:xfrm>
        </p:spPr>
        <p:txBody>
          <a:bodyPr>
            <a:normAutofit fontScale="90000"/>
          </a:bodyPr>
          <a:lstStyle/>
          <a:p>
            <a:r>
              <a:rPr lang="en-GB" dirty="0"/>
              <a:t>Supplementary Figures 1 A and B</a:t>
            </a:r>
            <a:br>
              <a:rPr lang="en-GB" dirty="0"/>
            </a:b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A86FBB7-219B-4ABD-9D79-46E73A982963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>
            <a:normAutofit lnSpcReduction="10000"/>
          </a:bodyPr>
          <a:lstStyle/>
          <a:p>
            <a:r>
              <a:rPr lang="en-GB" dirty="0"/>
              <a:t>Manuscript: Early Access Provision: Awareness, Educational Needs and Opportunities to Improve Oncology Patients’ Access to </a:t>
            </a:r>
            <a:r>
              <a:rPr lang="en-GB"/>
              <a:t>Care </a:t>
            </a:r>
          </a:p>
          <a:p>
            <a:endParaRPr lang="en-GB" dirty="0"/>
          </a:p>
          <a:p>
            <a:r>
              <a:rPr lang="en-GB" dirty="0" err="1"/>
              <a:t>A.Krendyukov</a:t>
            </a:r>
            <a:r>
              <a:rPr lang="en-GB" dirty="0"/>
              <a:t>, </a:t>
            </a:r>
            <a:r>
              <a:rPr lang="en-GB" dirty="0" err="1"/>
              <a:t>S.Singhvi</a:t>
            </a:r>
            <a:r>
              <a:rPr lang="en-GB" dirty="0"/>
              <a:t>, </a:t>
            </a:r>
            <a:r>
              <a:rPr lang="en-US" dirty="0" err="1"/>
              <a:t>Y.Green</a:t>
            </a:r>
            <a:r>
              <a:rPr lang="en-US" dirty="0"/>
              <a:t>-Morrison, </a:t>
            </a:r>
            <a:r>
              <a:rPr lang="en-US" dirty="0" err="1"/>
              <a:t>M.Zabransky</a:t>
            </a:r>
            <a:r>
              <a:rPr lang="en-US" b="1" dirty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617883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5076" y="216843"/>
            <a:ext cx="10515600" cy="1105330"/>
          </a:xfrm>
          <a:solidFill>
            <a:schemeClr val="bg1"/>
          </a:solidFill>
        </p:spPr>
        <p:txBody>
          <a:bodyPr>
            <a:normAutofit/>
          </a:bodyPr>
          <a:lstStyle/>
          <a:p>
            <a:r>
              <a:rPr lang="en-US" sz="2800" b="1" dirty="0"/>
              <a:t>Supplementary</a:t>
            </a:r>
            <a:r>
              <a:rPr lang="de-DE" sz="2800" b="1" dirty="0"/>
              <a:t> Figure 1 A</a:t>
            </a:r>
            <a:br>
              <a:rPr lang="de-DE" sz="2800" b="1" dirty="0"/>
            </a:br>
            <a:r>
              <a:rPr lang="en-US" sz="2400" dirty="0"/>
              <a:t>Regional and country specific breakdown of responders (practicing physicians) </a:t>
            </a:r>
          </a:p>
        </p:txBody>
      </p:sp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D7ECFD1D-1228-4BCC-AC44-F2E6FC3F269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7990447"/>
              </p:ext>
            </p:extLst>
          </p:nvPr>
        </p:nvGraphicFramePr>
        <p:xfrm>
          <a:off x="689365" y="1408671"/>
          <a:ext cx="11049554" cy="49674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itle 1"/>
          <p:cNvSpPr txBox="1">
            <a:spLocks/>
          </p:cNvSpPr>
          <p:nvPr/>
        </p:nvSpPr>
        <p:spPr>
          <a:xfrm>
            <a:off x="245076" y="6239186"/>
            <a:ext cx="10515600" cy="446797"/>
          </a:xfrm>
          <a:prstGeom prst="rect">
            <a:avLst/>
          </a:prstGeom>
          <a:solidFill>
            <a:schemeClr val="bg1"/>
          </a:solidFill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sz="1600" dirty="0"/>
              <a:t>APAC: </a:t>
            </a:r>
            <a:r>
              <a:rPr lang="de-DE" sz="1600" dirty="0" err="1"/>
              <a:t>Asia</a:t>
            </a:r>
            <a:r>
              <a:rPr lang="de-DE" sz="1600" dirty="0"/>
              <a:t> –Pacific Region 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13169889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2720" y="56205"/>
            <a:ext cx="10515600" cy="1105330"/>
          </a:xfrm>
          <a:solidFill>
            <a:schemeClr val="bg1"/>
          </a:solidFill>
        </p:spPr>
        <p:txBody>
          <a:bodyPr>
            <a:normAutofit/>
          </a:bodyPr>
          <a:lstStyle/>
          <a:p>
            <a:r>
              <a:rPr lang="en-US" sz="2800" b="1" dirty="0"/>
              <a:t>Supplementary</a:t>
            </a:r>
            <a:r>
              <a:rPr lang="de-DE" sz="2800" b="1" dirty="0"/>
              <a:t> Figure 1 B</a:t>
            </a:r>
            <a:br>
              <a:rPr lang="de-DE" sz="2800" b="1" dirty="0"/>
            </a:br>
            <a:r>
              <a:rPr lang="en-US" sz="2400" dirty="0"/>
              <a:t>Regional and country specific breakdown of responders (practicing physicians) </a:t>
            </a: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44246957-784B-449E-8E81-23D49B6AD4B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73623018"/>
              </p:ext>
            </p:extLst>
          </p:nvPr>
        </p:nvGraphicFramePr>
        <p:xfrm>
          <a:off x="232719" y="1161535"/>
          <a:ext cx="11740977" cy="55358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0627170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Custom 1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00FF81"/>
      </a:accent1>
      <a:accent2>
        <a:srgbClr val="08CFEE"/>
      </a:accent2>
      <a:accent3>
        <a:srgbClr val="FFEC00"/>
      </a:accent3>
      <a:accent4>
        <a:srgbClr val="FB90FF"/>
      </a:accent4>
      <a:accent5>
        <a:srgbClr val="FF8300"/>
      </a:accent5>
      <a:accent6>
        <a:srgbClr val="73FBFF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85</Words>
  <Application>Microsoft Office PowerPoint</Application>
  <PresentationFormat>Widescreen</PresentationFormat>
  <Paragraphs>1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Supplementary Figures 1 A and B </vt:lpstr>
      <vt:lpstr>Supplementary Figure 1 A Regional and country specific breakdown of responders (practicing physicians) </vt:lpstr>
      <vt:lpstr>Supplementary Figure 1 B Regional and country specific breakdown of responders (practicing physicians)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raphs for EAP</dc:title>
  <dc:creator>Yianick Green-Morrison</dc:creator>
  <cp:lastModifiedBy>Andriy Andriy</cp:lastModifiedBy>
  <cp:revision>22</cp:revision>
  <dcterms:created xsi:type="dcterms:W3CDTF">2021-05-14T10:53:58Z</dcterms:created>
  <dcterms:modified xsi:type="dcterms:W3CDTF">2022-10-21T08:53:12Z</dcterms:modified>
</cp:coreProperties>
</file>